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897"/>
  </p:normalViewPr>
  <p:slideViewPr>
    <p:cSldViewPr snapToGrid="0">
      <p:cViewPr varScale="1">
        <p:scale>
          <a:sx n="98" d="100"/>
          <a:sy n="98" d="100"/>
        </p:scale>
        <p:origin x="5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'Pie chart serotype distribution'!$K$36</c:f>
              <c:strCache>
                <c:ptCount val="1"/>
                <c:pt idx="0">
                  <c:v>&lt;1 year old</c:v>
                </c:pt>
              </c:strCache>
            </c:strRef>
          </c:tx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A44-F548-BBA1-D20D8DCA9290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A44-F548-BBA1-D20D8DCA9290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A44-F548-BBA1-D20D8DCA929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Pie chart serotype distribution'!$J$37:$J$39</c:f>
              <c:strCache>
                <c:ptCount val="3"/>
                <c:pt idx="0">
                  <c:v>Vaccine Serotype</c:v>
                </c:pt>
                <c:pt idx="1">
                  <c:v>Non-Vaccine Serotype</c:v>
                </c:pt>
                <c:pt idx="2">
                  <c:v>Nontypeable</c:v>
                </c:pt>
              </c:strCache>
            </c:strRef>
          </c:cat>
          <c:val>
            <c:numRef>
              <c:f>'Pie chart serotype distribution'!$K$37:$K$39</c:f>
              <c:numCache>
                <c:formatCode>0.0%</c:formatCode>
                <c:ptCount val="3"/>
                <c:pt idx="0">
                  <c:v>0.49795918367346897</c:v>
                </c:pt>
                <c:pt idx="1">
                  <c:v>0.37551020408163299</c:v>
                </c:pt>
                <c:pt idx="2">
                  <c:v>0.12653061224489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A44-F548-BBA1-D20D8DCA9290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tr"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'Pie chart serotype distribution'!$L$36</c:f>
              <c:strCache>
                <c:ptCount val="1"/>
                <c:pt idx="0">
                  <c:v>1-2 years old</c:v>
                </c:pt>
              </c:strCache>
            </c:strRef>
          </c:tx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A56-1C48-8C46-2F353741EE17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A56-1C48-8C46-2F353741EE17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A56-1C48-8C46-2F353741EE17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Pie chart serotype distribution'!$J$37:$J$39</c:f>
              <c:strCache>
                <c:ptCount val="3"/>
                <c:pt idx="0">
                  <c:v>Vaccine Serotype</c:v>
                </c:pt>
                <c:pt idx="1">
                  <c:v>Non-Vaccine Serotype</c:v>
                </c:pt>
                <c:pt idx="2">
                  <c:v>Nontypeable</c:v>
                </c:pt>
              </c:strCache>
            </c:strRef>
          </c:cat>
          <c:val>
            <c:numRef>
              <c:f>'Pie chart serotype distribution'!$L$37:$L$39</c:f>
              <c:numCache>
                <c:formatCode>0.0%</c:formatCode>
                <c:ptCount val="3"/>
                <c:pt idx="0">
                  <c:v>0.57874015748031504</c:v>
                </c:pt>
                <c:pt idx="1">
                  <c:v>0.31299212598425202</c:v>
                </c:pt>
                <c:pt idx="2">
                  <c:v>0.1082677165354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A56-1C48-8C46-2F353741EE17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tr"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'Pie chart serotype distribution'!$M$36</c:f>
              <c:strCache>
                <c:ptCount val="1"/>
                <c:pt idx="0">
                  <c:v>3-4 years old</c:v>
                </c:pt>
              </c:strCache>
            </c:strRef>
          </c:tx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979-464A-9E5B-16AED351B4FA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979-464A-9E5B-16AED351B4FA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979-464A-9E5B-16AED351B4F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Pie chart serotype distribution'!$J$37:$J$39</c:f>
              <c:strCache>
                <c:ptCount val="3"/>
                <c:pt idx="0">
                  <c:v>Vaccine Serotype</c:v>
                </c:pt>
                <c:pt idx="1">
                  <c:v>Non-Vaccine Serotype</c:v>
                </c:pt>
                <c:pt idx="2">
                  <c:v>Nontypeable</c:v>
                </c:pt>
              </c:strCache>
            </c:strRef>
          </c:cat>
          <c:val>
            <c:numRef>
              <c:f>'Pie chart serotype distribution'!$M$37:$M$39</c:f>
              <c:numCache>
                <c:formatCode>0.0%</c:formatCode>
                <c:ptCount val="3"/>
                <c:pt idx="0">
                  <c:v>0.52542372881355903</c:v>
                </c:pt>
                <c:pt idx="1">
                  <c:v>0.35310734463276799</c:v>
                </c:pt>
                <c:pt idx="2">
                  <c:v>0.1214689265536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979-464A-9E5B-16AED351B4FA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tr"/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B3B454-399E-E87A-F011-CC56509294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292C13-201E-5C98-F12A-05DFFF0A57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1EE40A-F9DC-374D-B143-1DCF7173C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413D10-E91C-F328-8BC3-08A18529C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39E0E2-5516-3200-EB11-22D105989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0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FAD64C-082D-B112-AE51-6B269B1FA3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46E47A-5E4D-FA37-E844-C14F4A4FB7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309FCE-E9B7-5FA1-C467-ABD958E22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74E9E-39BE-0110-A4E5-22627C1D3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A18144-5CD5-65BC-D607-58F666FA7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265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BCAAA7-ACD0-6C02-21EB-8D1AAE93C1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072938-7DF4-224E-825E-A67598B06F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983D63-2562-0E17-5D33-CA234C45D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EF89B-C3C2-1993-B632-2E6B1CD70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FEA19B-4459-6F8D-4B6E-758586B514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132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5A334-008B-1D00-B9D2-DBB24CA4D4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4D697A-3F79-A2D1-78FF-B50F9D6FC3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652A1A-1DBC-7499-3874-0F34D455B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797BF1-7185-54CB-635A-0D0DBAF62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A5AAC3-1E19-C20D-950D-112FDCEC2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83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3B8C62-0D93-A4E0-4C3F-2A747948B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6F3CD-EA49-C6A2-797B-D61EEA254F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EF8FEC-F3E0-2365-2DFE-FE530A66D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1C2D22-06E8-0F44-2868-FEEE799F6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1525B7-D34D-AAE9-EE24-EE8D17DD8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3018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F38BB-92C9-7229-01EE-95BAF4F296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B05D9C-BBEF-6178-7C18-5E1A9EFD03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1A6B9D-3B2F-EDDC-BF7B-76F3A7E2DB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E613B9-A9C7-95B1-62ED-657CF6A89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BBCFE8-D6F8-FD47-9888-82C750AAD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EB06A9-84DE-EC3D-E6A8-BDA2EBE18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679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9586FC-75B1-F747-926E-6A9C15F5F4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55C735-E1FC-7887-077D-B735AF15F7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F385E7-09F2-CE57-1E2B-8BBB6886F9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3DB9D9-8E9E-1793-5711-CE60940BF5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AE00A6-C7F3-4CDD-CE0F-2ABAF53DA1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C6843D-0F51-B992-12B1-40CEF80BB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028DFA-246C-76ED-DB0A-1E87CE18E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0D85F5C-270E-C019-25EF-BCD3BFCD79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32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00CC05-89B3-71EA-B159-B511CD8012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D0E27EF-7F3A-9AA8-407D-6FD76757E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0BAACEB-55B2-E441-C855-174A47BFB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124D8C-310C-F56F-77CE-EEA79057D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798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D7168D-3BBA-F92B-19EF-C02711682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C4BD1B-7731-78B9-08D9-8CFF9F763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97608C2-CC09-5714-2AFB-BE3FECECB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432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EEB305-499B-F637-C097-BFE53409E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24B235-3408-E071-1D79-1B0272435D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497EBB-BF7B-9A7C-936D-59AD4053C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A5F0E5-2BCC-FDBD-8393-E70C7D631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A05FE1-971F-8C4A-0895-933B43DAA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4E6CDB-CA79-A10D-21E1-97AE48B46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408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300208-1C58-5EAF-17B3-2533D166BB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F45888-FF9D-A941-9A5B-90BA74D889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BB548B-9B5A-BC61-1F9F-55DAF99F12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0D51DD-312A-E04D-8A7E-74020E039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FD12F5-6CCC-CF0E-DF9D-F862DBB1A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AB9385-EADE-7965-6556-934AC34212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861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93C972-B38A-98C2-A04F-3287C2C2BA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8EAB57-B2BC-A50B-2781-7C586B9722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7D3C23-C1BA-93BC-64CD-6825DC0A8A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67D8B-D8A1-BC47-BCEC-D917BF8355A7}" type="datetimeFigureOut">
              <a:rPr lang="en-US" smtClean="0"/>
              <a:t>1/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20B45D-6A8F-C14B-6A22-75CA6E623C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784376-296B-8C46-4A9B-8AF455659E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D4B7D9-5857-BD42-B00D-309D6D15B3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858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3D6C88A-5BC7-4B14-B01F-617AF5F704E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09799866"/>
              </p:ext>
            </p:extLst>
          </p:nvPr>
        </p:nvGraphicFramePr>
        <p:xfrm>
          <a:off x="1159726" y="771525"/>
          <a:ext cx="4258945" cy="2468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822945BE-C91E-4A86-8F35-4535CD564A7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759756895"/>
              </p:ext>
            </p:extLst>
          </p:nvPr>
        </p:nvGraphicFramePr>
        <p:xfrm>
          <a:off x="6269325" y="985521"/>
          <a:ext cx="4254500" cy="2468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DDDE9553-AC37-4DB3-B636-5B9DB60A3EA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770068502"/>
              </p:ext>
            </p:extLst>
          </p:nvPr>
        </p:nvGraphicFramePr>
        <p:xfrm>
          <a:off x="1250424" y="3554729"/>
          <a:ext cx="4254500" cy="2377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Rectangle 4">
            <a:extLst>
              <a:ext uri="{FF2B5EF4-FFF2-40B4-BE49-F238E27FC236}">
                <a16:creationId xmlns:a16="http://schemas.microsoft.com/office/drawing/2014/main" id="{813E0F4F-3E16-9638-ACFE-EB723ECD53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-54876" y="-138115"/>
            <a:ext cx="9992684" cy="15692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85584" tIns="685584" rIns="685584" bIns="685584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. Children &lt;1 year (N=245)					b. Children 1 – 2 years (N=508)</a:t>
            </a:r>
            <a:endParaRPr kumimoji="0" lang="en-US" altLang="zh-CN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D0095610-B179-3E37-5D00-F63BE39D44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572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78A07617-6F55-0711-7DC0-ABAB108121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258" y="3263126"/>
            <a:ext cx="11656741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 Children 3 – 4 years (N=358)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Rectangle 7">
            <a:extLst>
              <a:ext uri="{FF2B5EF4-FFF2-40B4-BE49-F238E27FC236}">
                <a16:creationId xmlns:a16="http://schemas.microsoft.com/office/drawing/2014/main" id="{D7E434F1-53B7-2921-325C-DB3014F41969}"/>
              </a:ext>
            </a:extLst>
          </p:cNvPr>
          <p:cNvSpPr>
            <a:spLocks noChangeArrowheads="1"/>
          </p:cNvSpPr>
          <p:nvPr/>
        </p:nvSpPr>
        <p:spPr bwMode="auto">
          <a:xfrm rot="10800000" flipV="1">
            <a:off x="367990" y="5892799"/>
            <a:ext cx="11277600" cy="7694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3000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‘Ns’ are the total number of pneumococcal isolates for each category.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3000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cine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erotypes were those included in PCV13 (1, 3, 4, 5, 6A, 6B, 7F, 9V, 14, 18C, 19A, 19F, and 23F). 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 pneumoniae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solates were deemed to be non-typeable if a serotype could not be determined by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mPCR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kumimoji="0" lang="en-US" altLang="en-US" sz="11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ellung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ut showed positive results for </a:t>
            </a:r>
            <a:r>
              <a:rPr kumimoji="0" lang="en-US" altLang="en-US" sz="1100" b="0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ytA</a:t>
            </a:r>
            <a:r>
              <a:rPr kumimoji="0" lang="en-US" altLang="en-US" sz="11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n-US" sz="11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. Non-vaccine serotypes were the remaining serotypes (i.e., not included in PCV13 or deemed non-typeable).</a:t>
            </a:r>
          </a:p>
        </p:txBody>
      </p:sp>
    </p:spTree>
    <p:extLst>
      <p:ext uri="{BB962C8B-B14F-4D97-AF65-F5344CB8AC3E}">
        <p14:creationId xmlns:p14="http://schemas.microsoft.com/office/powerpoint/2010/main" val="4101223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37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di Safari</dc:creator>
  <cp:lastModifiedBy>teti novianti</cp:lastModifiedBy>
  <cp:revision>2</cp:revision>
  <dcterms:created xsi:type="dcterms:W3CDTF">2023-07-09T16:15:43Z</dcterms:created>
  <dcterms:modified xsi:type="dcterms:W3CDTF">2024-01-01T12:24:15Z</dcterms:modified>
</cp:coreProperties>
</file>